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89" autoAdjust="0"/>
    <p:restoredTop sz="94660"/>
  </p:normalViewPr>
  <p:slideViewPr>
    <p:cSldViewPr snapToGrid="0">
      <p:cViewPr varScale="1">
        <p:scale>
          <a:sx n="86" d="100"/>
          <a:sy n="86" d="100"/>
        </p:scale>
        <p:origin x="922" y="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8BCBA0-6832-431F-8FE4-675567DB56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4224B2A-9AAB-458E-B9D7-AC4EA08DC0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173893-342F-45A8-B875-1B2E572C2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75628E-5CAC-4859-8F35-EF262BC390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F755ED-038B-408F-8B06-059A359441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3559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FFFCC5-A07A-4E2A-8C17-2ECE9887B6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C2891C7-A660-4E21-AB9C-B31452DB8D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0A18AA-3E9E-42D0-8A87-6659326CD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C811B0-8C00-4B69-B456-3C7EFFA48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8D21C1-3A3A-4F62-8F82-2BAB98682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2332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872D7E0-A940-4E9D-9201-9C8A396934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A021E03-EA82-4C52-A70F-BD854E8B7A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68767F-F194-49D4-A678-3001E3CAF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AC1BE8-3A76-4118-AEB9-72E08D77B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08ED768-0138-423E-8E93-4A1A6D83B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9122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7F17CE-31A3-45F3-A10F-EEAE1B3D6F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55C45AA-E9BA-491E-A839-1625EE6E3D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A0F743-9ADE-4583-A9D6-5D0A94CFB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FF37D2-8943-4F17-ADC5-3DACBCE6D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311425-C7DE-4F3D-8C58-C97C29D83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1337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3F991D-EEB9-47CD-AF86-3550881573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F3A505-F8AA-47E6-8770-4C49B885C3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D96B68-5D78-4B95-B7AB-122568B86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E38DCF-1C71-4FE4-B2EA-4C154A71B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2F0FC1D-88FC-49C5-AA5E-5BAF4CFE9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8706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CEF5CC-6D74-4736-87B2-186AED5E3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59B5FD6-405B-43E8-BCB8-EBAE1A1040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0E7BA13-937D-4535-BD4B-B24197F542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9C436E5-401F-43C5-9114-4EA0CABC6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8A6B42-387B-4E5E-B981-3A62B598C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95CB369-8E45-49A2-8751-7F9B5B50C7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6988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4CCFA6-2DB9-4D80-BBAF-9E0363205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92B3D55-3453-4D02-ABC1-B13E22062A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D7674F8-A92D-402F-8426-636B577889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089099E-5F3F-44FC-AFA2-C88CD56CCA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81DA0CF-5FCD-42E6-A264-ECDD5FA92A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700B944-88FD-4B9C-9D14-F6A40843A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C0E4491-9EC1-4F60-9F28-145AE7DAE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78F9BAE-5317-4F77-B8B3-968A45AD1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7186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02B04E-A8B3-4233-A948-51783287BB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1899F55-136C-4471-9095-CFF95AC05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5F837DF-4346-4951-90FE-70A26F22B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2E7C3F1-61FE-486C-A7E8-A9DCADE8E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1570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D80ECA5-9E1F-4C2E-91CB-A204C25F3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1FD4827-37CB-4C54-9294-E4AF4B386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A227FD2-4D79-4FE3-8CEA-F3A3DE5B7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4601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599C36-D03E-445A-8746-2CD4D06092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1C4C32E-91AC-40D1-A492-826E216489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44F1566-47CB-4719-82A6-CA1768D47C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E1CCFD7-AA6D-4E93-857D-316879951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1FB51E6-B4C0-474A-B170-40027C75C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ACC14F5-F7CE-4F46-8DBD-00CD301B1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9382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68F0D1-B4E5-435C-BCAB-6DB43F1332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4C66013-BD0A-46C1-9E3E-8F1C4C92B1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D4F8A5D-EB29-4436-BD3B-6E31B1784A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9058AB3-C309-4A3C-9B17-44A04052A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FE0A5FD-C8C4-41D6-A1D4-21846EF78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187C55-F26A-40B7-A2FE-7AE1229CF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8474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F23B534-7DD7-40E8-8A1E-E130645987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D10949F-5457-4AF2-AB18-7BB9E54BC9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E875BF-FD59-4C56-A7F1-BB232CC8FC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697433-48A6-4D5E-8800-3359D370F24C}" type="datetimeFigureOut">
              <a:rPr lang="zh-CN" altLang="en-US" smtClean="0"/>
              <a:t>2020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D30B95-9C0E-41AE-9F4D-9FC338AD68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DF302D-C43D-482B-AC9C-A0DB63C387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5ADEDF-6DD8-4CE1-AB3E-5D7277E00BF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8438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箭头: 右 45">
            <a:extLst>
              <a:ext uri="{FF2B5EF4-FFF2-40B4-BE49-F238E27FC236}">
                <a16:creationId xmlns:a16="http://schemas.microsoft.com/office/drawing/2014/main" id="{B676393F-5709-4E82-AAA3-01C64A46293B}"/>
              </a:ext>
            </a:extLst>
          </p:cNvPr>
          <p:cNvSpPr/>
          <p:nvPr/>
        </p:nvSpPr>
        <p:spPr>
          <a:xfrm>
            <a:off x="2107057" y="2914910"/>
            <a:ext cx="1202931" cy="161923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爆炸形: 8 pt  41">
            <a:extLst>
              <a:ext uri="{FF2B5EF4-FFF2-40B4-BE49-F238E27FC236}">
                <a16:creationId xmlns:a16="http://schemas.microsoft.com/office/drawing/2014/main" id="{9E00A617-0AA9-4660-A469-7D515135B87D}"/>
              </a:ext>
            </a:extLst>
          </p:cNvPr>
          <p:cNvSpPr/>
          <p:nvPr/>
        </p:nvSpPr>
        <p:spPr>
          <a:xfrm>
            <a:off x="1816305" y="3455147"/>
            <a:ext cx="1609111" cy="1302002"/>
          </a:xfrm>
          <a:prstGeom prst="irregularSeal1">
            <a:avLst/>
          </a:prstGeom>
          <a:effectLst>
            <a:softEdge rad="12700"/>
          </a:effectLst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13" name="箭头: 右弧形 112">
            <a:extLst>
              <a:ext uri="{FF2B5EF4-FFF2-40B4-BE49-F238E27FC236}">
                <a16:creationId xmlns:a16="http://schemas.microsoft.com/office/drawing/2014/main" id="{183FB57D-2C19-4560-8AE6-1D8422E87CA8}"/>
              </a:ext>
            </a:extLst>
          </p:cNvPr>
          <p:cNvSpPr/>
          <p:nvPr/>
        </p:nvSpPr>
        <p:spPr>
          <a:xfrm>
            <a:off x="8888826" y="2965720"/>
            <a:ext cx="339265" cy="949256"/>
          </a:xfrm>
          <a:prstGeom prst="curved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tx1"/>
              </a:solidFill>
            </a:endParaRPr>
          </a:p>
        </p:txBody>
      </p:sp>
      <p:sp>
        <p:nvSpPr>
          <p:cNvPr id="108" name="箭头: 右 107">
            <a:extLst>
              <a:ext uri="{FF2B5EF4-FFF2-40B4-BE49-F238E27FC236}">
                <a16:creationId xmlns:a16="http://schemas.microsoft.com/office/drawing/2014/main" id="{EF669949-EADA-4ACA-8CE8-F77009419A50}"/>
              </a:ext>
            </a:extLst>
          </p:cNvPr>
          <p:cNvSpPr/>
          <p:nvPr/>
        </p:nvSpPr>
        <p:spPr>
          <a:xfrm>
            <a:off x="7351828" y="2921235"/>
            <a:ext cx="468720" cy="178326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6" name="箭头: 右 105">
            <a:extLst>
              <a:ext uri="{FF2B5EF4-FFF2-40B4-BE49-F238E27FC236}">
                <a16:creationId xmlns:a16="http://schemas.microsoft.com/office/drawing/2014/main" id="{6868B3B5-45CA-49A3-AF83-05E6D0E2E202}"/>
              </a:ext>
            </a:extLst>
          </p:cNvPr>
          <p:cNvSpPr/>
          <p:nvPr/>
        </p:nvSpPr>
        <p:spPr>
          <a:xfrm rot="16200000">
            <a:off x="7419818" y="3199444"/>
            <a:ext cx="257419" cy="126322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8" name="箭头: 右 97">
            <a:extLst>
              <a:ext uri="{FF2B5EF4-FFF2-40B4-BE49-F238E27FC236}">
                <a16:creationId xmlns:a16="http://schemas.microsoft.com/office/drawing/2014/main" id="{1ED00543-34E8-4CA8-9042-62A36242EA2A}"/>
              </a:ext>
            </a:extLst>
          </p:cNvPr>
          <p:cNvSpPr/>
          <p:nvPr/>
        </p:nvSpPr>
        <p:spPr>
          <a:xfrm>
            <a:off x="5311035" y="2918766"/>
            <a:ext cx="1202931" cy="161923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8C97643A-5AEB-F540-A438-D0095218017A}"/>
              </a:ext>
            </a:extLst>
          </p:cNvPr>
          <p:cNvGrpSpPr/>
          <p:nvPr/>
        </p:nvGrpSpPr>
        <p:grpSpPr>
          <a:xfrm>
            <a:off x="4669335" y="1091404"/>
            <a:ext cx="2381340" cy="1524006"/>
            <a:chOff x="4669335" y="1091404"/>
            <a:chExt cx="2381340" cy="1524006"/>
          </a:xfrm>
        </p:grpSpPr>
        <p:sp>
          <p:nvSpPr>
            <p:cNvPr id="65" name="椭圆 64">
              <a:extLst>
                <a:ext uri="{FF2B5EF4-FFF2-40B4-BE49-F238E27FC236}">
                  <a16:creationId xmlns:a16="http://schemas.microsoft.com/office/drawing/2014/main" id="{86DA188F-F30B-4A82-B232-E8D01303799B}"/>
                </a:ext>
              </a:extLst>
            </p:cNvPr>
            <p:cNvSpPr/>
            <p:nvPr/>
          </p:nvSpPr>
          <p:spPr>
            <a:xfrm>
              <a:off x="4669335" y="1091404"/>
              <a:ext cx="2381340" cy="1524006"/>
            </a:xfrm>
            <a:prstGeom prst="ellipse">
              <a:avLst/>
            </a:prstGeom>
            <a:effectLst>
              <a:softEdge rad="12700"/>
            </a:effectLst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2C450DE7-934F-4226-84C3-7BFD1EB168B2}"/>
                </a:ext>
              </a:extLst>
            </p:cNvPr>
            <p:cNvSpPr txBox="1"/>
            <p:nvPr/>
          </p:nvSpPr>
          <p:spPr>
            <a:xfrm>
              <a:off x="4981580" y="1261906"/>
              <a:ext cx="19514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0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entose phosphate pathway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椭圆 89">
              <a:extLst>
                <a:ext uri="{FF2B5EF4-FFF2-40B4-BE49-F238E27FC236}">
                  <a16:creationId xmlns:a16="http://schemas.microsoft.com/office/drawing/2014/main" id="{0CA17B37-3F8C-43D5-97F2-248BAA2D5F01}"/>
                </a:ext>
              </a:extLst>
            </p:cNvPr>
            <p:cNvSpPr/>
            <p:nvPr/>
          </p:nvSpPr>
          <p:spPr>
            <a:xfrm>
              <a:off x="4785154" y="1538905"/>
              <a:ext cx="2119922" cy="1003908"/>
            </a:xfrm>
            <a:prstGeom prst="ellipse">
              <a:avLst/>
            </a:prstGeom>
            <a:effectLst>
              <a:softEdge rad="31750"/>
            </a:effectLst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67" name="组合 66">
              <a:extLst>
                <a:ext uri="{FF2B5EF4-FFF2-40B4-BE49-F238E27FC236}">
                  <a16:creationId xmlns:a16="http://schemas.microsoft.com/office/drawing/2014/main" id="{3962315E-1769-411F-B3F8-F9BD6009050A}"/>
                </a:ext>
              </a:extLst>
            </p:cNvPr>
            <p:cNvGrpSpPr/>
            <p:nvPr/>
          </p:nvGrpSpPr>
          <p:grpSpPr>
            <a:xfrm>
              <a:off x="4865424" y="1791666"/>
              <a:ext cx="578717" cy="422916"/>
              <a:chOff x="2695203" y="2598180"/>
              <a:chExt cx="624523" cy="533677"/>
            </a:xfrm>
          </p:grpSpPr>
          <p:sp>
            <p:nvSpPr>
              <p:cNvPr id="77" name="椭圆 76">
                <a:extLst>
                  <a:ext uri="{FF2B5EF4-FFF2-40B4-BE49-F238E27FC236}">
                    <a16:creationId xmlns:a16="http://schemas.microsoft.com/office/drawing/2014/main" id="{50289A8F-FAAB-4962-9271-209B5844135D}"/>
                  </a:ext>
                </a:extLst>
              </p:cNvPr>
              <p:cNvSpPr/>
              <p:nvPr/>
            </p:nvSpPr>
            <p:spPr>
              <a:xfrm>
                <a:off x="2712120" y="2598180"/>
                <a:ext cx="493690" cy="533677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0814C79B-8B58-4CBD-BF97-4B2CCDBECA75}"/>
                  </a:ext>
                </a:extLst>
              </p:cNvPr>
              <p:cNvSpPr txBox="1"/>
              <p:nvPr/>
            </p:nvSpPr>
            <p:spPr>
              <a:xfrm>
                <a:off x="2695203" y="2695173"/>
                <a:ext cx="624523" cy="3107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</a:t>
                </a:r>
                <a:endParaRPr lang="zh-CN" alt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96B2BFF3-4844-45A8-99E5-FB2FC3FA4A0B}"/>
                </a:ext>
              </a:extLst>
            </p:cNvPr>
            <p:cNvGrpSpPr/>
            <p:nvPr/>
          </p:nvGrpSpPr>
          <p:grpSpPr>
            <a:xfrm>
              <a:off x="5180066" y="1943248"/>
              <a:ext cx="590567" cy="422916"/>
              <a:chOff x="2712120" y="2598180"/>
              <a:chExt cx="637311" cy="533677"/>
            </a:xfrm>
          </p:grpSpPr>
          <p:sp>
            <p:nvSpPr>
              <p:cNvPr id="81" name="椭圆 80">
                <a:extLst>
                  <a:ext uri="{FF2B5EF4-FFF2-40B4-BE49-F238E27FC236}">
                    <a16:creationId xmlns:a16="http://schemas.microsoft.com/office/drawing/2014/main" id="{4A0B7818-CAC9-4C7E-9F02-E5F79B865D03}"/>
                  </a:ext>
                </a:extLst>
              </p:cNvPr>
              <p:cNvSpPr/>
              <p:nvPr/>
            </p:nvSpPr>
            <p:spPr>
              <a:xfrm>
                <a:off x="2712120" y="2598180"/>
                <a:ext cx="493690" cy="533677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D259ABE4-C079-4736-A818-1DDF1B832D91}"/>
                  </a:ext>
                </a:extLst>
              </p:cNvPr>
              <p:cNvSpPr txBox="1"/>
              <p:nvPr/>
            </p:nvSpPr>
            <p:spPr>
              <a:xfrm>
                <a:off x="2724908" y="2713731"/>
                <a:ext cx="624523" cy="3107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KL1</a:t>
                </a:r>
                <a:endParaRPr lang="zh-CN" alt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id="{3F560B03-CE9E-41AE-8FA8-1C5982D23230}"/>
                </a:ext>
              </a:extLst>
            </p:cNvPr>
            <p:cNvGrpSpPr/>
            <p:nvPr/>
          </p:nvGrpSpPr>
          <p:grpSpPr>
            <a:xfrm>
              <a:off x="5574755" y="1762913"/>
              <a:ext cx="590567" cy="422916"/>
              <a:chOff x="2712120" y="2598180"/>
              <a:chExt cx="637311" cy="533677"/>
            </a:xfrm>
          </p:grpSpPr>
          <p:sp>
            <p:nvSpPr>
              <p:cNvPr id="84" name="椭圆 83">
                <a:extLst>
                  <a:ext uri="{FF2B5EF4-FFF2-40B4-BE49-F238E27FC236}">
                    <a16:creationId xmlns:a16="http://schemas.microsoft.com/office/drawing/2014/main" id="{11BFFBAB-675B-44BE-969D-44E9A755B9F3}"/>
                  </a:ext>
                </a:extLst>
              </p:cNvPr>
              <p:cNvSpPr/>
              <p:nvPr/>
            </p:nvSpPr>
            <p:spPr>
              <a:xfrm>
                <a:off x="2712120" y="2598180"/>
                <a:ext cx="493690" cy="533677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866A7D65-A7F6-4B2C-8204-BF437F999299}"/>
                  </a:ext>
                </a:extLst>
              </p:cNvPr>
              <p:cNvSpPr txBox="1"/>
              <p:nvPr/>
            </p:nvSpPr>
            <p:spPr>
              <a:xfrm>
                <a:off x="2724908" y="2713731"/>
                <a:ext cx="624523" cy="3107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PE1</a:t>
                </a:r>
                <a:endParaRPr lang="zh-CN" alt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6" name="组合 85">
              <a:extLst>
                <a:ext uri="{FF2B5EF4-FFF2-40B4-BE49-F238E27FC236}">
                  <a16:creationId xmlns:a16="http://schemas.microsoft.com/office/drawing/2014/main" id="{6CDB7004-542D-4713-9D31-8EFF91A56058}"/>
                </a:ext>
              </a:extLst>
            </p:cNvPr>
            <p:cNvGrpSpPr/>
            <p:nvPr/>
          </p:nvGrpSpPr>
          <p:grpSpPr>
            <a:xfrm>
              <a:off x="5821200" y="2070849"/>
              <a:ext cx="590567" cy="422916"/>
              <a:chOff x="2712120" y="2598180"/>
              <a:chExt cx="637311" cy="533677"/>
            </a:xfrm>
          </p:grpSpPr>
          <p:sp>
            <p:nvSpPr>
              <p:cNvPr id="87" name="椭圆 86">
                <a:extLst>
                  <a:ext uri="{FF2B5EF4-FFF2-40B4-BE49-F238E27FC236}">
                    <a16:creationId xmlns:a16="http://schemas.microsoft.com/office/drawing/2014/main" id="{B3C728A1-31B8-4696-B850-03B501832721}"/>
                  </a:ext>
                </a:extLst>
              </p:cNvPr>
              <p:cNvSpPr/>
              <p:nvPr/>
            </p:nvSpPr>
            <p:spPr>
              <a:xfrm>
                <a:off x="2712120" y="2598180"/>
                <a:ext cx="493690" cy="533677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AEEF05BA-6772-4E26-803D-96A02948CEBA}"/>
                  </a:ext>
                </a:extLst>
              </p:cNvPr>
              <p:cNvSpPr txBox="1"/>
              <p:nvPr/>
            </p:nvSpPr>
            <p:spPr>
              <a:xfrm>
                <a:off x="2724908" y="2713731"/>
                <a:ext cx="624523" cy="3107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KI1</a:t>
                </a:r>
                <a:endParaRPr lang="zh-CN" alt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B39AABE1-9CFF-43C2-9DFC-776175E44105}"/>
                </a:ext>
              </a:extLst>
            </p:cNvPr>
            <p:cNvSpPr txBox="1"/>
            <p:nvPr/>
          </p:nvSpPr>
          <p:spPr>
            <a:xfrm>
              <a:off x="6010396" y="1800168"/>
              <a:ext cx="9226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8 Plasmid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0" name="箭头: 右 59">
            <a:extLst>
              <a:ext uri="{FF2B5EF4-FFF2-40B4-BE49-F238E27FC236}">
                <a16:creationId xmlns:a16="http://schemas.microsoft.com/office/drawing/2014/main" id="{42F6ECCD-B9D4-46B3-94DB-84D56B7699D6}"/>
              </a:ext>
            </a:extLst>
          </p:cNvPr>
          <p:cNvSpPr/>
          <p:nvPr/>
        </p:nvSpPr>
        <p:spPr>
          <a:xfrm>
            <a:off x="3763320" y="2889373"/>
            <a:ext cx="944660" cy="215417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箭头: 右 55">
            <a:extLst>
              <a:ext uri="{FF2B5EF4-FFF2-40B4-BE49-F238E27FC236}">
                <a16:creationId xmlns:a16="http://schemas.microsoft.com/office/drawing/2014/main" id="{C4F4DCCD-5277-445B-8057-9E15EB20C76A}"/>
              </a:ext>
            </a:extLst>
          </p:cNvPr>
          <p:cNvSpPr/>
          <p:nvPr/>
        </p:nvSpPr>
        <p:spPr>
          <a:xfrm rot="15248746">
            <a:off x="4089122" y="3264156"/>
            <a:ext cx="257419" cy="126322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箭头: 右 11">
            <a:extLst>
              <a:ext uri="{FF2B5EF4-FFF2-40B4-BE49-F238E27FC236}">
                <a16:creationId xmlns:a16="http://schemas.microsoft.com/office/drawing/2014/main" id="{C69A3894-7A61-49B7-97A7-8A1E9AA25DC1}"/>
              </a:ext>
            </a:extLst>
          </p:cNvPr>
          <p:cNvSpPr/>
          <p:nvPr/>
        </p:nvSpPr>
        <p:spPr>
          <a:xfrm rot="15248746">
            <a:off x="4350303" y="4008247"/>
            <a:ext cx="257419" cy="126322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箭头: 右 33">
            <a:extLst>
              <a:ext uri="{FF2B5EF4-FFF2-40B4-BE49-F238E27FC236}">
                <a16:creationId xmlns:a16="http://schemas.microsoft.com/office/drawing/2014/main" id="{F28060C2-ED56-4807-8FC7-137AE0C650CB}"/>
              </a:ext>
            </a:extLst>
          </p:cNvPr>
          <p:cNvSpPr/>
          <p:nvPr/>
        </p:nvSpPr>
        <p:spPr>
          <a:xfrm rot="7124100">
            <a:off x="2796106" y="2085959"/>
            <a:ext cx="221050" cy="124954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80A9F121-9D13-4FE4-B2C5-93A158A7EB61}"/>
              </a:ext>
            </a:extLst>
          </p:cNvPr>
          <p:cNvGrpSpPr/>
          <p:nvPr/>
        </p:nvGrpSpPr>
        <p:grpSpPr>
          <a:xfrm>
            <a:off x="826735" y="1794407"/>
            <a:ext cx="1083071" cy="379974"/>
            <a:chOff x="834501" y="1987715"/>
            <a:chExt cx="1083071" cy="379974"/>
          </a:xfrm>
        </p:grpSpPr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4D3BE1E9-A5C9-4E8E-9B94-A2E9E1320D36}"/>
                </a:ext>
              </a:extLst>
            </p:cNvPr>
            <p:cNvSpPr/>
            <p:nvPr/>
          </p:nvSpPr>
          <p:spPr>
            <a:xfrm>
              <a:off x="834501" y="1987715"/>
              <a:ext cx="1047566" cy="379974"/>
            </a:xfrm>
            <a:prstGeom prst="rect">
              <a:avLst/>
            </a:prstGeom>
            <a:effectLst>
              <a:softEdge rad="31750"/>
            </a:effectLst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3C5F9D28-402F-4EDA-B046-1E140DA0F4EF}"/>
                </a:ext>
              </a:extLst>
            </p:cNvPr>
            <p:cNvSpPr txBox="1"/>
            <p:nvPr/>
          </p:nvSpPr>
          <p:spPr>
            <a:xfrm>
              <a:off x="878885" y="1987715"/>
              <a:ext cx="1038687" cy="3799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C-DM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" name="箭头: 右 8">
            <a:extLst>
              <a:ext uri="{FF2B5EF4-FFF2-40B4-BE49-F238E27FC236}">
                <a16:creationId xmlns:a16="http://schemas.microsoft.com/office/drawing/2014/main" id="{6BA6043B-7F76-438B-8ADB-483C25F35BA8}"/>
              </a:ext>
            </a:extLst>
          </p:cNvPr>
          <p:cNvSpPr/>
          <p:nvPr/>
        </p:nvSpPr>
        <p:spPr>
          <a:xfrm rot="5400000">
            <a:off x="1055033" y="2386419"/>
            <a:ext cx="601012" cy="122067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903541CA-09EE-4203-900F-3C8B64EB42E4}"/>
              </a:ext>
            </a:extLst>
          </p:cNvPr>
          <p:cNvGrpSpPr/>
          <p:nvPr/>
        </p:nvGrpSpPr>
        <p:grpSpPr>
          <a:xfrm>
            <a:off x="672483" y="2784057"/>
            <a:ext cx="1473693" cy="379974"/>
            <a:chOff x="834501" y="1987715"/>
            <a:chExt cx="1047566" cy="379974"/>
          </a:xfrm>
        </p:grpSpPr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58BAD469-5803-4B7F-8AEC-908D671E37FD}"/>
                </a:ext>
              </a:extLst>
            </p:cNvPr>
            <p:cNvSpPr/>
            <p:nvPr/>
          </p:nvSpPr>
          <p:spPr>
            <a:xfrm>
              <a:off x="834501" y="1987715"/>
              <a:ext cx="1047566" cy="379974"/>
            </a:xfrm>
            <a:prstGeom prst="rect">
              <a:avLst/>
            </a:prstGeom>
            <a:effectLst>
              <a:softEdge rad="31750"/>
            </a:effectLst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2EECA2FC-CC05-48DE-9B2F-55418DFCB6DD}"/>
                </a:ext>
              </a:extLst>
            </p:cNvPr>
            <p:cNvSpPr txBox="1"/>
            <p:nvPr/>
          </p:nvSpPr>
          <p:spPr>
            <a:xfrm>
              <a:off x="914832" y="2023813"/>
              <a:ext cx="8869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0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aploid strain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72B0961D-DC30-4E04-94DF-97A7BCB85440}"/>
              </a:ext>
            </a:extLst>
          </p:cNvPr>
          <p:cNvGrpSpPr/>
          <p:nvPr/>
        </p:nvGrpSpPr>
        <p:grpSpPr>
          <a:xfrm>
            <a:off x="2065624" y="344139"/>
            <a:ext cx="2448019" cy="1710741"/>
            <a:chOff x="2135074" y="337351"/>
            <a:chExt cx="2448019" cy="1710741"/>
          </a:xfrm>
        </p:grpSpPr>
        <p:sp>
          <p:nvSpPr>
            <p:cNvPr id="17" name="椭圆 16">
              <a:extLst>
                <a:ext uri="{FF2B5EF4-FFF2-40B4-BE49-F238E27FC236}">
                  <a16:creationId xmlns:a16="http://schemas.microsoft.com/office/drawing/2014/main" id="{DEB61E24-EF98-4D20-BE0D-6FECF1AAD909}"/>
                </a:ext>
              </a:extLst>
            </p:cNvPr>
            <p:cNvSpPr/>
            <p:nvPr/>
          </p:nvSpPr>
          <p:spPr>
            <a:xfrm>
              <a:off x="2135074" y="337351"/>
              <a:ext cx="2286006" cy="1710741"/>
            </a:xfrm>
            <a:prstGeom prst="ellipse">
              <a:avLst/>
            </a:prstGeom>
            <a:effectLst>
              <a:softEdge rad="31750"/>
            </a:effectLst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3C8DA27-A15B-4E69-8762-82AE88ED2873}"/>
                </a:ext>
              </a:extLst>
            </p:cNvPr>
            <p:cNvSpPr txBox="1"/>
            <p:nvPr/>
          </p:nvSpPr>
          <p:spPr>
            <a:xfrm>
              <a:off x="2549337" y="487370"/>
              <a:ext cx="14315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0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R mutants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23180514-27A4-4FB5-B239-BD65772C2BB2}"/>
                </a:ext>
              </a:extLst>
            </p:cNvPr>
            <p:cNvGrpSpPr/>
            <p:nvPr/>
          </p:nvGrpSpPr>
          <p:grpSpPr>
            <a:xfrm>
              <a:off x="2268241" y="864763"/>
              <a:ext cx="661390" cy="589123"/>
              <a:chOff x="2712123" y="2531965"/>
              <a:chExt cx="743507" cy="662268"/>
            </a:xfrm>
          </p:grpSpPr>
          <p:sp>
            <p:nvSpPr>
              <p:cNvPr id="20" name="椭圆 19">
                <a:extLst>
                  <a:ext uri="{FF2B5EF4-FFF2-40B4-BE49-F238E27FC236}">
                    <a16:creationId xmlns:a16="http://schemas.microsoft.com/office/drawing/2014/main" id="{27861F0D-7A58-44E0-A93C-8C1B5A23DEAB}"/>
                  </a:ext>
                </a:extLst>
              </p:cNvPr>
              <p:cNvSpPr/>
              <p:nvPr/>
            </p:nvSpPr>
            <p:spPr>
              <a:xfrm>
                <a:off x="2712123" y="2531965"/>
                <a:ext cx="662267" cy="662268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C80F08DC-170D-4120-AC28-B26C3A769CB0}"/>
                  </a:ext>
                </a:extLst>
              </p:cNvPr>
              <p:cNvSpPr txBox="1"/>
              <p:nvPr/>
            </p:nvSpPr>
            <p:spPr>
              <a:xfrm>
                <a:off x="2712123" y="2732294"/>
                <a:ext cx="74350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270G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628775BE-9D35-427B-A7DE-A0DCD1C378F5}"/>
                </a:ext>
              </a:extLst>
            </p:cNvPr>
            <p:cNvGrpSpPr/>
            <p:nvPr/>
          </p:nvGrpSpPr>
          <p:grpSpPr>
            <a:xfrm>
              <a:off x="3327873" y="1281082"/>
              <a:ext cx="661390" cy="589123"/>
              <a:chOff x="2712123" y="2531965"/>
              <a:chExt cx="743507" cy="662268"/>
            </a:xfrm>
          </p:grpSpPr>
          <p:sp>
            <p:nvSpPr>
              <p:cNvPr id="27" name="椭圆 26">
                <a:extLst>
                  <a:ext uri="{FF2B5EF4-FFF2-40B4-BE49-F238E27FC236}">
                    <a16:creationId xmlns:a16="http://schemas.microsoft.com/office/drawing/2014/main" id="{94739806-6B04-42CA-94B5-6EC8754BB0F6}"/>
                  </a:ext>
                </a:extLst>
              </p:cNvPr>
              <p:cNvSpPr/>
              <p:nvPr/>
            </p:nvSpPr>
            <p:spPr>
              <a:xfrm>
                <a:off x="2712123" y="2531965"/>
                <a:ext cx="662267" cy="662268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8AD4DFF0-5EEB-4CAA-A64B-29C62ACE927E}"/>
                  </a:ext>
                </a:extLst>
              </p:cNvPr>
              <p:cNvSpPr txBox="1"/>
              <p:nvPr/>
            </p:nvSpPr>
            <p:spPr>
              <a:xfrm>
                <a:off x="2712123" y="2732294"/>
                <a:ext cx="743507" cy="2940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270R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27F9E68C-2AD8-48AD-BFC8-24DABE868B01}"/>
                </a:ext>
              </a:extLst>
            </p:cNvPr>
            <p:cNvGrpSpPr/>
            <p:nvPr/>
          </p:nvGrpSpPr>
          <p:grpSpPr>
            <a:xfrm>
              <a:off x="3441066" y="723911"/>
              <a:ext cx="1142027" cy="699106"/>
              <a:chOff x="2694509" y="2531965"/>
              <a:chExt cx="849127" cy="662268"/>
            </a:xfrm>
          </p:grpSpPr>
          <p:sp>
            <p:nvSpPr>
              <p:cNvPr id="30" name="椭圆 29">
                <a:extLst>
                  <a:ext uri="{FF2B5EF4-FFF2-40B4-BE49-F238E27FC236}">
                    <a16:creationId xmlns:a16="http://schemas.microsoft.com/office/drawing/2014/main" id="{F2A171C3-4266-4BCB-9ECF-9E2D4D1BEE2D}"/>
                  </a:ext>
                </a:extLst>
              </p:cNvPr>
              <p:cNvSpPr/>
              <p:nvPr/>
            </p:nvSpPr>
            <p:spPr>
              <a:xfrm>
                <a:off x="2712123" y="2531965"/>
                <a:ext cx="662267" cy="662268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2C19E0E6-872C-4E75-BA64-9CA7D4B5D789}"/>
                  </a:ext>
                </a:extLst>
              </p:cNvPr>
              <p:cNvSpPr txBox="1"/>
              <p:nvPr/>
            </p:nvSpPr>
            <p:spPr>
              <a:xfrm>
                <a:off x="2694509" y="2742116"/>
                <a:ext cx="849127" cy="2493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effectLst/>
                    <a:latin typeface="Times New Roman" panose="02020603050405020304" pitchFamily="18" charset="0"/>
                    <a:ea typeface="宋体" panose="02010600030101010101" pitchFamily="2" charset="-122"/>
                  </a:rPr>
                  <a:t>K270RN272D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66A19350-EB53-477D-A9F5-469212D46684}"/>
                </a:ext>
              </a:extLst>
            </p:cNvPr>
            <p:cNvGrpSpPr/>
            <p:nvPr/>
          </p:nvGrpSpPr>
          <p:grpSpPr>
            <a:xfrm>
              <a:off x="2779676" y="1181918"/>
              <a:ext cx="661390" cy="589123"/>
              <a:chOff x="2712123" y="2531965"/>
              <a:chExt cx="743507" cy="662268"/>
            </a:xfrm>
          </p:grpSpPr>
          <p:sp>
            <p:nvSpPr>
              <p:cNvPr id="24" name="椭圆 23">
                <a:extLst>
                  <a:ext uri="{FF2B5EF4-FFF2-40B4-BE49-F238E27FC236}">
                    <a16:creationId xmlns:a16="http://schemas.microsoft.com/office/drawing/2014/main" id="{9E44A49D-B694-4EEB-9388-B6CD7D836D91}"/>
                  </a:ext>
                </a:extLst>
              </p:cNvPr>
              <p:cNvSpPr/>
              <p:nvPr/>
            </p:nvSpPr>
            <p:spPr>
              <a:xfrm>
                <a:off x="2712123" y="2531965"/>
                <a:ext cx="662267" cy="662268"/>
              </a:xfrm>
              <a:prstGeom prst="ellipse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2B86B199-5395-4088-B681-DEC6B008FEC2}"/>
                  </a:ext>
                </a:extLst>
              </p:cNvPr>
              <p:cNvSpPr txBox="1"/>
              <p:nvPr/>
            </p:nvSpPr>
            <p:spPr>
              <a:xfrm>
                <a:off x="2712123" y="2732294"/>
                <a:ext cx="743507" cy="2940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270M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2A89A080-5681-4327-A60D-120D3730905F}"/>
              </a:ext>
            </a:extLst>
          </p:cNvPr>
          <p:cNvGrpSpPr/>
          <p:nvPr/>
        </p:nvGrpSpPr>
        <p:grpSpPr>
          <a:xfrm rot="21143371">
            <a:off x="3871365" y="3449585"/>
            <a:ext cx="1121756" cy="481928"/>
            <a:chOff x="3954828" y="4793851"/>
            <a:chExt cx="712331" cy="589123"/>
          </a:xfrm>
        </p:grpSpPr>
        <p:sp>
          <p:nvSpPr>
            <p:cNvPr id="13" name="椭圆 12">
              <a:extLst>
                <a:ext uri="{FF2B5EF4-FFF2-40B4-BE49-F238E27FC236}">
                  <a16:creationId xmlns:a16="http://schemas.microsoft.com/office/drawing/2014/main" id="{A6D983FB-D8CE-42D3-B17B-81E75D5516CC}"/>
                </a:ext>
              </a:extLst>
            </p:cNvPr>
            <p:cNvSpPr/>
            <p:nvPr/>
          </p:nvSpPr>
          <p:spPr>
            <a:xfrm>
              <a:off x="3954828" y="4793851"/>
              <a:ext cx="589123" cy="589123"/>
            </a:xfrm>
            <a:prstGeom prst="ellipse">
              <a:avLst/>
            </a:prstGeom>
            <a:effectLst>
              <a:softEdge rad="12700"/>
            </a:effectLst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595CCC8A-1D41-4EEE-8914-3554BFD1CCD6}"/>
                </a:ext>
              </a:extLst>
            </p:cNvPr>
            <p:cNvSpPr txBox="1"/>
            <p:nvPr/>
          </p:nvSpPr>
          <p:spPr>
            <a:xfrm>
              <a:off x="3966765" y="4949708"/>
              <a:ext cx="700394" cy="319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XT7-XYL1</a:t>
              </a:r>
              <a:endParaRPr lang="zh-CN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0BE262F8-721A-4FB0-93A3-FDE7A13BAA78}"/>
              </a:ext>
            </a:extLst>
          </p:cNvPr>
          <p:cNvGrpSpPr/>
          <p:nvPr/>
        </p:nvGrpSpPr>
        <p:grpSpPr>
          <a:xfrm>
            <a:off x="4694424" y="2816048"/>
            <a:ext cx="663077" cy="379974"/>
            <a:chOff x="834501" y="1987715"/>
            <a:chExt cx="1047566" cy="379974"/>
          </a:xfrm>
        </p:grpSpPr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7780ECCD-7282-4A39-B94B-CDA5B3EEBA84}"/>
                </a:ext>
              </a:extLst>
            </p:cNvPr>
            <p:cNvSpPr/>
            <p:nvPr/>
          </p:nvSpPr>
          <p:spPr>
            <a:xfrm>
              <a:off x="834501" y="1987715"/>
              <a:ext cx="1047566" cy="379974"/>
            </a:xfrm>
            <a:prstGeom prst="rect">
              <a:avLst/>
            </a:prstGeom>
            <a:effectLst>
              <a:softEdge rad="31750"/>
            </a:effectLst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E072C8C2-96A6-4789-97CE-6CCB21DF1BE6}"/>
                </a:ext>
              </a:extLst>
            </p:cNvPr>
            <p:cNvSpPr txBox="1"/>
            <p:nvPr/>
          </p:nvSpPr>
          <p:spPr>
            <a:xfrm>
              <a:off x="898937" y="2028429"/>
              <a:ext cx="9831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0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9H1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9" name="组合 98">
            <a:extLst>
              <a:ext uri="{FF2B5EF4-FFF2-40B4-BE49-F238E27FC236}">
                <a16:creationId xmlns:a16="http://schemas.microsoft.com/office/drawing/2014/main" id="{3ADF0110-7EC7-416A-A282-438EDE4A6E9C}"/>
              </a:ext>
            </a:extLst>
          </p:cNvPr>
          <p:cNvGrpSpPr/>
          <p:nvPr/>
        </p:nvGrpSpPr>
        <p:grpSpPr>
          <a:xfrm>
            <a:off x="6534256" y="2805703"/>
            <a:ext cx="876671" cy="379974"/>
            <a:chOff x="834501" y="1987715"/>
            <a:chExt cx="1047566" cy="379974"/>
          </a:xfrm>
        </p:grpSpPr>
        <p:sp>
          <p:nvSpPr>
            <p:cNvPr id="100" name="矩形 99">
              <a:extLst>
                <a:ext uri="{FF2B5EF4-FFF2-40B4-BE49-F238E27FC236}">
                  <a16:creationId xmlns:a16="http://schemas.microsoft.com/office/drawing/2014/main" id="{F6429418-7073-4319-B0CD-31DC73B84C7C}"/>
                </a:ext>
              </a:extLst>
            </p:cNvPr>
            <p:cNvSpPr/>
            <p:nvPr/>
          </p:nvSpPr>
          <p:spPr>
            <a:xfrm>
              <a:off x="834501" y="1987715"/>
              <a:ext cx="1047566" cy="379974"/>
            </a:xfrm>
            <a:prstGeom prst="rect">
              <a:avLst/>
            </a:prstGeom>
            <a:effectLst>
              <a:softEdge rad="31750"/>
            </a:effectLst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BD56E1D8-864D-4628-A619-7D79B5E63359}"/>
                </a:ext>
              </a:extLst>
            </p:cNvPr>
            <p:cNvSpPr txBox="1"/>
            <p:nvPr/>
          </p:nvSpPr>
          <p:spPr>
            <a:xfrm>
              <a:off x="898937" y="2028429"/>
              <a:ext cx="9831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0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9H1B8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2" name="组合 101">
            <a:extLst>
              <a:ext uri="{FF2B5EF4-FFF2-40B4-BE49-F238E27FC236}">
                <a16:creationId xmlns:a16="http://schemas.microsoft.com/office/drawing/2014/main" id="{E013801E-78E8-41B4-BF54-71E79E51541F}"/>
              </a:ext>
            </a:extLst>
          </p:cNvPr>
          <p:cNvGrpSpPr/>
          <p:nvPr/>
        </p:nvGrpSpPr>
        <p:grpSpPr>
          <a:xfrm>
            <a:off x="7084661" y="3361708"/>
            <a:ext cx="1121756" cy="481928"/>
            <a:chOff x="3954828" y="4793851"/>
            <a:chExt cx="712331" cy="589123"/>
          </a:xfrm>
        </p:grpSpPr>
        <p:sp>
          <p:nvSpPr>
            <p:cNvPr id="103" name="椭圆 102">
              <a:extLst>
                <a:ext uri="{FF2B5EF4-FFF2-40B4-BE49-F238E27FC236}">
                  <a16:creationId xmlns:a16="http://schemas.microsoft.com/office/drawing/2014/main" id="{15A24946-BDC7-486C-B2F5-ABBA5A1AB934}"/>
                </a:ext>
              </a:extLst>
            </p:cNvPr>
            <p:cNvSpPr/>
            <p:nvPr/>
          </p:nvSpPr>
          <p:spPr>
            <a:xfrm>
              <a:off x="3954828" y="4793851"/>
              <a:ext cx="589123" cy="589123"/>
            </a:xfrm>
            <a:prstGeom prst="ellipse">
              <a:avLst/>
            </a:prstGeom>
            <a:effectLst>
              <a:softEdge rad="12700"/>
            </a:effectLst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B4563842-5262-4C0E-BF6E-B2A8011A3715}"/>
                </a:ext>
              </a:extLst>
            </p:cNvPr>
            <p:cNvSpPr txBox="1"/>
            <p:nvPr/>
          </p:nvSpPr>
          <p:spPr>
            <a:xfrm>
              <a:off x="3966765" y="4949708"/>
              <a:ext cx="700394" cy="319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XT7-XYL2</a:t>
              </a:r>
              <a:endParaRPr lang="zh-CN" alt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9" name="组合 108">
            <a:extLst>
              <a:ext uri="{FF2B5EF4-FFF2-40B4-BE49-F238E27FC236}">
                <a16:creationId xmlns:a16="http://schemas.microsoft.com/office/drawing/2014/main" id="{ECB76C34-9A79-4098-8741-82C7F10DA9C6}"/>
              </a:ext>
            </a:extLst>
          </p:cNvPr>
          <p:cNvGrpSpPr/>
          <p:nvPr/>
        </p:nvGrpSpPr>
        <p:grpSpPr>
          <a:xfrm>
            <a:off x="7850285" y="2806499"/>
            <a:ext cx="1109768" cy="379974"/>
            <a:chOff x="834501" y="1987715"/>
            <a:chExt cx="1047566" cy="379974"/>
          </a:xfrm>
        </p:grpSpPr>
        <p:sp>
          <p:nvSpPr>
            <p:cNvPr id="110" name="矩形 109">
              <a:extLst>
                <a:ext uri="{FF2B5EF4-FFF2-40B4-BE49-F238E27FC236}">
                  <a16:creationId xmlns:a16="http://schemas.microsoft.com/office/drawing/2014/main" id="{D9F4E3AD-ACFC-47FB-8B71-4B91A5801804}"/>
                </a:ext>
              </a:extLst>
            </p:cNvPr>
            <p:cNvSpPr/>
            <p:nvPr/>
          </p:nvSpPr>
          <p:spPr>
            <a:xfrm>
              <a:off x="834501" y="1987715"/>
              <a:ext cx="1047566" cy="379974"/>
            </a:xfrm>
            <a:prstGeom prst="rect">
              <a:avLst/>
            </a:prstGeom>
            <a:effectLst>
              <a:softEdge rad="31750"/>
            </a:effectLst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30220525-4F85-473A-921D-CAD25E281DA3}"/>
                </a:ext>
              </a:extLst>
            </p:cNvPr>
            <p:cNvSpPr txBox="1"/>
            <p:nvPr/>
          </p:nvSpPr>
          <p:spPr>
            <a:xfrm>
              <a:off x="898937" y="2028429"/>
              <a:ext cx="9831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0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9H1H2B8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B40B38B6-7FDD-41DA-9585-13721BCCD108}"/>
              </a:ext>
            </a:extLst>
          </p:cNvPr>
          <p:cNvGrpSpPr/>
          <p:nvPr/>
        </p:nvGrpSpPr>
        <p:grpSpPr>
          <a:xfrm>
            <a:off x="2517777" y="2240016"/>
            <a:ext cx="585168" cy="507478"/>
            <a:chOff x="2958826" y="2112247"/>
            <a:chExt cx="661390" cy="589123"/>
          </a:xfrm>
        </p:grpSpPr>
        <p:sp>
          <p:nvSpPr>
            <p:cNvPr id="37" name="椭圆 36">
              <a:extLst>
                <a:ext uri="{FF2B5EF4-FFF2-40B4-BE49-F238E27FC236}">
                  <a16:creationId xmlns:a16="http://schemas.microsoft.com/office/drawing/2014/main" id="{F7745C11-0AA4-415F-9DBB-3202EA4CABAC}"/>
                </a:ext>
              </a:extLst>
            </p:cNvPr>
            <p:cNvSpPr/>
            <p:nvPr/>
          </p:nvSpPr>
          <p:spPr>
            <a:xfrm>
              <a:off x="2983515" y="2112247"/>
              <a:ext cx="589123" cy="589123"/>
            </a:xfrm>
            <a:prstGeom prst="ellipse">
              <a:avLst/>
            </a:prstGeom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E21C429D-AD2F-468D-ACD1-9AB2EF46F187}"/>
                </a:ext>
              </a:extLst>
            </p:cNvPr>
            <p:cNvSpPr txBox="1"/>
            <p:nvPr/>
          </p:nvSpPr>
          <p:spPr>
            <a:xfrm>
              <a:off x="2958826" y="2271904"/>
              <a:ext cx="661390" cy="269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270R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8" name="箭头: 右弧形 37">
            <a:extLst>
              <a:ext uri="{FF2B5EF4-FFF2-40B4-BE49-F238E27FC236}">
                <a16:creationId xmlns:a16="http://schemas.microsoft.com/office/drawing/2014/main" id="{7323F44D-BAE0-44B4-9EC2-FD927F95C1B5}"/>
              </a:ext>
            </a:extLst>
          </p:cNvPr>
          <p:cNvSpPr/>
          <p:nvPr/>
        </p:nvSpPr>
        <p:spPr>
          <a:xfrm rot="2340566">
            <a:off x="3131091" y="2967906"/>
            <a:ext cx="324641" cy="1176846"/>
          </a:xfrm>
          <a:prstGeom prst="curvedLeftArrow">
            <a:avLst>
              <a:gd name="adj1" fmla="val 25000"/>
              <a:gd name="adj2" fmla="val 50000"/>
              <a:gd name="adj3" fmla="val 53525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870B2B7E-C83D-4C08-9DAA-8E5BB743283A}"/>
              </a:ext>
            </a:extLst>
          </p:cNvPr>
          <p:cNvGrpSpPr/>
          <p:nvPr/>
        </p:nvGrpSpPr>
        <p:grpSpPr>
          <a:xfrm>
            <a:off x="3343131" y="2803034"/>
            <a:ext cx="511948" cy="379974"/>
            <a:chOff x="834501" y="1987715"/>
            <a:chExt cx="1103777" cy="379974"/>
          </a:xfrm>
        </p:grpSpPr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0D0BE7E2-D1F8-4EB3-AEAB-A8D5F2DF8DA4}"/>
                </a:ext>
              </a:extLst>
            </p:cNvPr>
            <p:cNvSpPr/>
            <p:nvPr/>
          </p:nvSpPr>
          <p:spPr>
            <a:xfrm>
              <a:off x="834501" y="1987715"/>
              <a:ext cx="1047566" cy="379974"/>
            </a:xfrm>
            <a:prstGeom prst="rect">
              <a:avLst/>
            </a:prstGeom>
            <a:effectLst>
              <a:softEdge rad="31750"/>
            </a:effectLst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468D4547-77A2-4951-9740-E39CFAE79DD6}"/>
                </a:ext>
              </a:extLst>
            </p:cNvPr>
            <p:cNvSpPr txBox="1"/>
            <p:nvPr/>
          </p:nvSpPr>
          <p:spPr>
            <a:xfrm>
              <a:off x="955148" y="2023813"/>
              <a:ext cx="9831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0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9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1" name="文本框 50">
            <a:extLst>
              <a:ext uri="{FF2B5EF4-FFF2-40B4-BE49-F238E27FC236}">
                <a16:creationId xmlns:a16="http://schemas.microsoft.com/office/drawing/2014/main" id="{FFF1FC3C-879B-448C-9AC1-02F9CAB7DDAC}"/>
              </a:ext>
            </a:extLst>
          </p:cNvPr>
          <p:cNvSpPr txBox="1"/>
          <p:nvPr/>
        </p:nvSpPr>
        <p:spPr>
          <a:xfrm>
            <a:off x="1928915" y="3888721"/>
            <a:ext cx="150420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-fold difference in xylitol accumulation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880A68AD-3404-8649-8409-D2349955C7ED}"/>
              </a:ext>
            </a:extLst>
          </p:cNvPr>
          <p:cNvGrpSpPr/>
          <p:nvPr/>
        </p:nvGrpSpPr>
        <p:grpSpPr>
          <a:xfrm>
            <a:off x="3475378" y="4104350"/>
            <a:ext cx="3123724" cy="1662555"/>
            <a:chOff x="3348053" y="4104350"/>
            <a:chExt cx="3123724" cy="1662555"/>
          </a:xfrm>
        </p:grpSpPr>
        <p:sp>
          <p:nvSpPr>
            <p:cNvPr id="2" name="椭圆 1">
              <a:extLst>
                <a:ext uri="{FF2B5EF4-FFF2-40B4-BE49-F238E27FC236}">
                  <a16:creationId xmlns:a16="http://schemas.microsoft.com/office/drawing/2014/main" id="{25242925-48DD-41E0-963F-2220EE9A326A}"/>
                </a:ext>
              </a:extLst>
            </p:cNvPr>
            <p:cNvSpPr/>
            <p:nvPr/>
          </p:nvSpPr>
          <p:spPr>
            <a:xfrm>
              <a:off x="3348053" y="4104350"/>
              <a:ext cx="3123724" cy="1662555"/>
            </a:xfrm>
            <a:prstGeom prst="ellipse">
              <a:avLst/>
            </a:prstGeom>
            <a:effectLst>
              <a:softEdge rad="31750"/>
            </a:effectLst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16F6149B-1749-451B-841B-FACD99FB82E0}"/>
                </a:ext>
              </a:extLst>
            </p:cNvPr>
            <p:cNvGrpSpPr/>
            <p:nvPr/>
          </p:nvGrpSpPr>
          <p:grpSpPr>
            <a:xfrm>
              <a:off x="3937231" y="4696550"/>
              <a:ext cx="589123" cy="471758"/>
              <a:chOff x="3431199" y="4034520"/>
              <a:chExt cx="589123" cy="589123"/>
            </a:xfrm>
          </p:grpSpPr>
          <p:sp>
            <p:nvSpPr>
              <p:cNvPr id="4" name="椭圆 3">
                <a:extLst>
                  <a:ext uri="{FF2B5EF4-FFF2-40B4-BE49-F238E27FC236}">
                    <a16:creationId xmlns:a16="http://schemas.microsoft.com/office/drawing/2014/main" id="{259FE647-5AC3-4EB1-94D6-1EBA5552D0BA}"/>
                  </a:ext>
                </a:extLst>
              </p:cNvPr>
              <p:cNvSpPr/>
              <p:nvPr/>
            </p:nvSpPr>
            <p:spPr>
              <a:xfrm>
                <a:off x="3431199" y="4034520"/>
                <a:ext cx="589123" cy="589123"/>
              </a:xfrm>
              <a:prstGeom prst="ellipse">
                <a:avLst/>
              </a:prstGeom>
            </p:spPr>
            <p:style>
              <a:lnRef idx="1">
                <a:schemeClr val="accent5"/>
              </a:lnRef>
              <a:fillRef idx="2">
                <a:schemeClr val="accent5"/>
              </a:fillRef>
              <a:effectRef idx="1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802502C1-6DA9-4FE0-B80E-5D1CB1F39A58}"/>
                  </a:ext>
                </a:extLst>
              </p:cNvPr>
              <p:cNvSpPr txBox="1"/>
              <p:nvPr/>
            </p:nvSpPr>
            <p:spPr>
              <a:xfrm>
                <a:off x="3462257" y="4209711"/>
                <a:ext cx="527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BA1</a:t>
                </a:r>
                <a:endParaRPr lang="zh-CN" alt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3" name="组合 42">
              <a:extLst>
                <a:ext uri="{FF2B5EF4-FFF2-40B4-BE49-F238E27FC236}">
                  <a16:creationId xmlns:a16="http://schemas.microsoft.com/office/drawing/2014/main" id="{B09BD90D-4011-4FC8-B595-33A5FE90830A}"/>
                </a:ext>
              </a:extLst>
            </p:cNvPr>
            <p:cNvGrpSpPr/>
            <p:nvPr/>
          </p:nvGrpSpPr>
          <p:grpSpPr>
            <a:xfrm>
              <a:off x="3945959" y="4230400"/>
              <a:ext cx="589123" cy="477270"/>
              <a:chOff x="3400140" y="4050567"/>
              <a:chExt cx="589123" cy="589123"/>
            </a:xfrm>
          </p:grpSpPr>
          <p:sp>
            <p:nvSpPr>
              <p:cNvPr id="44" name="椭圆 43">
                <a:extLst>
                  <a:ext uri="{FF2B5EF4-FFF2-40B4-BE49-F238E27FC236}">
                    <a16:creationId xmlns:a16="http://schemas.microsoft.com/office/drawing/2014/main" id="{ED2B863C-2BB5-4454-AE80-F1A748744451}"/>
                  </a:ext>
                </a:extLst>
              </p:cNvPr>
              <p:cNvSpPr/>
              <p:nvPr/>
            </p:nvSpPr>
            <p:spPr>
              <a:xfrm>
                <a:off x="3400140" y="4050567"/>
                <a:ext cx="589123" cy="589123"/>
              </a:xfrm>
              <a:prstGeom prst="ellipse">
                <a:avLst/>
              </a:prstGeom>
            </p:spPr>
            <p:style>
              <a:lnRef idx="1">
                <a:schemeClr val="accent5"/>
              </a:lnRef>
              <a:fillRef idx="2">
                <a:schemeClr val="accent5"/>
              </a:fillRef>
              <a:effectRef idx="1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27CF0486-5CCB-4A8B-BA3E-90A5EEFD2B0F}"/>
                  </a:ext>
                </a:extLst>
              </p:cNvPr>
              <p:cNvSpPr txBox="1"/>
              <p:nvPr/>
            </p:nvSpPr>
            <p:spPr>
              <a:xfrm>
                <a:off x="3462257" y="4209711"/>
                <a:ext cx="52700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XT7</a:t>
                </a:r>
                <a:endParaRPr lang="zh-CN" alt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9D6196AE-B1BD-4FF1-836F-F726EFAA9450}"/>
                </a:ext>
              </a:extLst>
            </p:cNvPr>
            <p:cNvGrpSpPr/>
            <p:nvPr/>
          </p:nvGrpSpPr>
          <p:grpSpPr>
            <a:xfrm>
              <a:off x="3945598" y="5092931"/>
              <a:ext cx="576475" cy="497264"/>
              <a:chOff x="3431199" y="4034520"/>
              <a:chExt cx="589123" cy="589123"/>
            </a:xfrm>
          </p:grpSpPr>
          <p:sp>
            <p:nvSpPr>
              <p:cNvPr id="49" name="椭圆 48">
                <a:extLst>
                  <a:ext uri="{FF2B5EF4-FFF2-40B4-BE49-F238E27FC236}">
                    <a16:creationId xmlns:a16="http://schemas.microsoft.com/office/drawing/2014/main" id="{30F3C802-CAC5-4A25-A7B2-B7F85FD85CFB}"/>
                  </a:ext>
                </a:extLst>
              </p:cNvPr>
              <p:cNvSpPr/>
              <p:nvPr/>
            </p:nvSpPr>
            <p:spPr>
              <a:xfrm>
                <a:off x="3431199" y="4034520"/>
                <a:ext cx="589123" cy="589123"/>
              </a:xfrm>
              <a:prstGeom prst="ellipse">
                <a:avLst/>
              </a:prstGeom>
            </p:spPr>
            <p:style>
              <a:lnRef idx="1">
                <a:schemeClr val="accent5"/>
              </a:lnRef>
              <a:fillRef idx="2">
                <a:schemeClr val="accent5"/>
              </a:fillRef>
              <a:effectRef idx="1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916B3DCE-5D16-4477-8E03-1F2011AF64FE}"/>
                  </a:ext>
                </a:extLst>
              </p:cNvPr>
              <p:cNvSpPr txBox="1"/>
              <p:nvPr/>
            </p:nvSpPr>
            <p:spPr>
              <a:xfrm>
                <a:off x="3462257" y="4209711"/>
                <a:ext cx="527006" cy="2616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F1</a:t>
                </a:r>
                <a:endParaRPr lang="zh-CN" alt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968DF304-9CDE-4DDD-91B3-CA0CFCFF6563}"/>
                </a:ext>
              </a:extLst>
            </p:cNvPr>
            <p:cNvSpPr txBox="1"/>
            <p:nvPr/>
          </p:nvSpPr>
          <p:spPr>
            <a:xfrm>
              <a:off x="4686918" y="5041237"/>
              <a:ext cx="165899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0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creening xylose</a:t>
              </a:r>
            </a:p>
            <a:p>
              <a:pPr algn="ctr"/>
              <a:r>
                <a:rPr lang="en-US" altLang="zh-CN" sz="1400" b="0" i="0" u="none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romoters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EACFCD1F-7E41-4CE3-A343-26EDFA93B090}"/>
                </a:ext>
              </a:extLst>
            </p:cNvPr>
            <p:cNvSpPr/>
            <p:nvPr/>
          </p:nvSpPr>
          <p:spPr>
            <a:xfrm>
              <a:off x="4513811" y="4361805"/>
              <a:ext cx="1436000" cy="20727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effectLst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4313D5BC-548F-49F5-A874-C500E9520A30}"/>
                </a:ext>
              </a:extLst>
            </p:cNvPr>
            <p:cNvSpPr/>
            <p:nvPr/>
          </p:nvSpPr>
          <p:spPr>
            <a:xfrm>
              <a:off x="4514967" y="4817986"/>
              <a:ext cx="421254" cy="153509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effectLst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F2B05011-DAF8-4F9E-B623-60ADB3353598}"/>
                </a:ext>
              </a:extLst>
            </p:cNvPr>
            <p:cNvSpPr/>
            <p:nvPr/>
          </p:nvSpPr>
          <p:spPr>
            <a:xfrm>
              <a:off x="4523638" y="5264748"/>
              <a:ext cx="205928" cy="146518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effectLst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642B9189-A109-46E2-A448-75056B9A65E9}"/>
                </a:ext>
              </a:extLst>
            </p:cNvPr>
            <p:cNvSpPr txBox="1"/>
            <p:nvPr/>
          </p:nvSpPr>
          <p:spPr>
            <a:xfrm>
              <a:off x="4497014" y="4308750"/>
              <a:ext cx="165434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expression levels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5" name="箭头: 右 105">
            <a:extLst>
              <a:ext uri="{FF2B5EF4-FFF2-40B4-BE49-F238E27FC236}">
                <a16:creationId xmlns:a16="http://schemas.microsoft.com/office/drawing/2014/main" id="{722FC8BA-E381-9544-B7F5-24DFB07DD55E}"/>
              </a:ext>
            </a:extLst>
          </p:cNvPr>
          <p:cNvSpPr/>
          <p:nvPr/>
        </p:nvSpPr>
        <p:spPr>
          <a:xfrm rot="5400000" flipV="1">
            <a:off x="5778143" y="2738382"/>
            <a:ext cx="257419" cy="126322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4" name="箭头: 右 105">
            <a:extLst>
              <a:ext uri="{FF2B5EF4-FFF2-40B4-BE49-F238E27FC236}">
                <a16:creationId xmlns:a16="http://schemas.microsoft.com/office/drawing/2014/main" id="{BC10F5A1-44DA-824C-B682-DF0C8A3DE719}"/>
              </a:ext>
            </a:extLst>
          </p:cNvPr>
          <p:cNvSpPr/>
          <p:nvPr/>
        </p:nvSpPr>
        <p:spPr>
          <a:xfrm rot="5400000" flipV="1">
            <a:off x="2667732" y="2797334"/>
            <a:ext cx="175998" cy="116848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7B5FC24-53DE-4708-8BFA-792E98FC84CD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6599102" y="3750816"/>
            <a:ext cx="3541910" cy="2716679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2A0C2383-04E1-4581-A7E4-6CD8CA2F0E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5481" y="3550381"/>
            <a:ext cx="3438171" cy="26268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671792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3401.5748031496064,&quot;width&quot;:4435.8377952755909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8</TotalTime>
  <Words>40</Words>
  <Application>Microsoft Office PowerPoint</Application>
  <PresentationFormat>宽屏</PresentationFormat>
  <Paragraphs>2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易玄 朱</dc:creator>
  <cp:lastModifiedBy>易玄 朱</cp:lastModifiedBy>
  <cp:revision>42</cp:revision>
  <dcterms:created xsi:type="dcterms:W3CDTF">2020-09-02T09:33:36Z</dcterms:created>
  <dcterms:modified xsi:type="dcterms:W3CDTF">2020-09-14T09:18:40Z</dcterms:modified>
</cp:coreProperties>
</file>